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5" d="100"/>
          <a:sy n="65" d="100"/>
        </p:scale>
        <p:origin x="-150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5215702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32055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16895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752607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87381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163425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310108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54506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75458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6497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877191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795B35-7E37-4516-8697-F4A0AF72A9F8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80982F-8BDB-4DBE-9470-E7B2E603E04E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099666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Skupina 3"/>
          <p:cNvGrpSpPr/>
          <p:nvPr/>
        </p:nvGrpSpPr>
        <p:grpSpPr>
          <a:xfrm>
            <a:off x="1492032" y="232884"/>
            <a:ext cx="6131823" cy="5184938"/>
            <a:chOff x="13321655" y="3420000"/>
            <a:chExt cx="6131823" cy="5184938"/>
          </a:xfrm>
        </p:grpSpPr>
        <p:sp>
          <p:nvSpPr>
            <p:cNvPr id="5" name="Kosoúhelník 4"/>
            <p:cNvSpPr/>
            <p:nvPr/>
          </p:nvSpPr>
          <p:spPr>
            <a:xfrm flipH="1">
              <a:off x="17999999" y="5362924"/>
              <a:ext cx="719997" cy="2880000"/>
            </a:xfrm>
            <a:prstGeom prst="parallelogram">
              <a:avLst>
                <a:gd name="adj" fmla="val 50135"/>
              </a:avLst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sp>
          <p:nvSpPr>
            <p:cNvPr id="6" name="Vývojový diagram: postup 5"/>
            <p:cNvSpPr/>
            <p:nvPr/>
          </p:nvSpPr>
          <p:spPr>
            <a:xfrm>
              <a:off x="17280000" y="5362924"/>
              <a:ext cx="720000" cy="2880000"/>
            </a:xfrm>
            <a:prstGeom prst="flowChartProcess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/>
            </a:p>
          </p:txBody>
        </p:sp>
        <p:grpSp>
          <p:nvGrpSpPr>
            <p:cNvPr id="7" name="Skupina 6"/>
            <p:cNvGrpSpPr/>
            <p:nvPr/>
          </p:nvGrpSpPr>
          <p:grpSpPr>
            <a:xfrm>
              <a:off x="17280000" y="3420000"/>
              <a:ext cx="1115788" cy="2302924"/>
              <a:chOff x="17316000" y="3457076"/>
              <a:chExt cx="1115788" cy="2302924"/>
            </a:xfrm>
          </p:grpSpPr>
          <p:sp>
            <p:nvSpPr>
              <p:cNvPr id="23" name="Šipka doprava 22"/>
              <p:cNvSpPr/>
              <p:nvPr/>
            </p:nvSpPr>
            <p:spPr>
              <a:xfrm rot="10800000">
                <a:off x="17316000" y="5040000"/>
                <a:ext cx="360000" cy="720000"/>
              </a:xfrm>
              <a:prstGeom prst="rightArrow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ovéPole 23"/>
              <p:cNvSpPr txBox="1"/>
              <p:nvPr/>
            </p:nvSpPr>
            <p:spPr>
              <a:xfrm rot="16200000">
                <a:off x="16740000" y="4068000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i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5" name="Šipka doprava 24"/>
              <p:cNvSpPr/>
              <p:nvPr/>
            </p:nvSpPr>
            <p:spPr>
              <a:xfrm>
                <a:off x="17676000" y="5040000"/>
                <a:ext cx="360000" cy="720000"/>
              </a:xfrm>
              <a:prstGeom prst="rightArrow">
                <a:avLst/>
              </a:prstGeom>
              <a:solidFill>
                <a:srgbClr val="FF00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ovéPole 25"/>
              <p:cNvSpPr txBox="1"/>
              <p:nvPr/>
            </p:nvSpPr>
            <p:spPr>
              <a:xfrm rot="16200000">
                <a:off x="17033647" y="4068000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a</a:t>
                </a:r>
                <a:r>
                  <a:rPr lang="en-US" sz="1600" i="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A-244</a:t>
                </a:r>
                <a:endParaRPr lang="en-US" sz="1600" baseline="-25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Šipka doprava 26"/>
              <p:cNvSpPr/>
              <p:nvPr/>
            </p:nvSpPr>
            <p:spPr>
              <a:xfrm rot="10800000">
                <a:off x="18036000" y="5040000"/>
                <a:ext cx="360000" cy="720000"/>
              </a:xfrm>
              <a:prstGeom prst="rightArrow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ovéPole 27"/>
              <p:cNvSpPr txBox="1"/>
              <p:nvPr/>
            </p:nvSpPr>
            <p:spPr>
              <a:xfrm rot="16200000">
                <a:off x="17482310" y="4068000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i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</p:grpSp>
        <p:grpSp>
          <p:nvGrpSpPr>
            <p:cNvPr id="8" name="Skupina 7"/>
            <p:cNvGrpSpPr/>
            <p:nvPr/>
          </p:nvGrpSpPr>
          <p:grpSpPr>
            <a:xfrm>
              <a:off x="17280000" y="6300000"/>
              <a:ext cx="1453478" cy="2304938"/>
              <a:chOff x="17280000" y="6300000"/>
              <a:chExt cx="1453478" cy="2304938"/>
            </a:xfrm>
          </p:grpSpPr>
          <p:sp>
            <p:nvSpPr>
              <p:cNvPr id="15" name="Šipka doprava 14"/>
              <p:cNvSpPr/>
              <p:nvPr/>
            </p:nvSpPr>
            <p:spPr>
              <a:xfrm rot="10800000">
                <a:off x="17280000" y="7882924"/>
                <a:ext cx="360000" cy="720000"/>
              </a:xfrm>
              <a:prstGeom prst="rightArrow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ovéPole 15"/>
              <p:cNvSpPr txBox="1"/>
              <p:nvPr/>
            </p:nvSpPr>
            <p:spPr>
              <a:xfrm rot="16200000">
                <a:off x="16704000" y="6910924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i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7" name="Šipka doprava 16"/>
              <p:cNvSpPr/>
              <p:nvPr/>
            </p:nvSpPr>
            <p:spPr>
              <a:xfrm>
                <a:off x="17640000" y="7882924"/>
                <a:ext cx="360000" cy="720000"/>
              </a:xfrm>
              <a:prstGeom prst="rightArrow">
                <a:avLst/>
              </a:prstGeom>
              <a:solidFill>
                <a:srgbClr val="FF00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ovéPole 17"/>
              <p:cNvSpPr txBox="1"/>
              <p:nvPr/>
            </p:nvSpPr>
            <p:spPr>
              <a:xfrm rot="16200000">
                <a:off x="16997647" y="6910924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la</a:t>
                </a:r>
                <a:r>
                  <a:rPr lang="en-US" sz="1600" i="0" baseline="-25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XA-244</a:t>
                </a:r>
                <a:endParaRPr lang="en-US" sz="1600" baseline="-25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Šipka doprava 18"/>
              <p:cNvSpPr/>
              <p:nvPr/>
            </p:nvSpPr>
            <p:spPr>
              <a:xfrm rot="10800000">
                <a:off x="18000000" y="7882924"/>
                <a:ext cx="360000" cy="720000"/>
              </a:xfrm>
              <a:prstGeom prst="rightArrow">
                <a:avLst/>
              </a:prstGeom>
              <a:solidFill>
                <a:schemeClr val="bg1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ovéPole 19"/>
              <p:cNvSpPr txBox="1"/>
              <p:nvPr/>
            </p:nvSpPr>
            <p:spPr>
              <a:xfrm rot="16200000">
                <a:off x="17784000" y="6910924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i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US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21" name="Šipka doprava 20"/>
              <p:cNvSpPr/>
              <p:nvPr/>
            </p:nvSpPr>
            <p:spPr>
              <a:xfrm rot="10800000">
                <a:off x="18360000" y="7884938"/>
                <a:ext cx="360000" cy="720000"/>
              </a:xfrm>
              <a:prstGeom prst="rightArrow">
                <a:avLst/>
              </a:prstGeom>
              <a:solidFill>
                <a:srgbClr val="FFFF00"/>
              </a:solidFill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cs-CZ" sz="1600">
                  <a:solidFill>
                    <a:prstClr val="white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ovéPole 21"/>
              <p:cNvSpPr txBox="1"/>
              <p:nvPr/>
            </p:nvSpPr>
            <p:spPr>
              <a:xfrm rot="16200000">
                <a:off x="17460000" y="6912000"/>
                <a:ext cx="15604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cs-CZ"/>
                </a:defPPr>
                <a:lvl1pPr>
                  <a:defRPr sz="2200" i="1">
                    <a:solidFill>
                      <a:prstClr val="black"/>
                    </a:solidFill>
                  </a:defRPr>
                </a:lvl1pPr>
              </a:lstStyle>
              <a:p>
                <a:r>
                  <a:rPr lang="en-US" sz="1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ysR</a:t>
                </a:r>
                <a:endParaRPr lang="en-US" sz="1600" baseline="-25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9" name="Přímá spojnice 8"/>
            <p:cNvCxnSpPr>
              <a:stCxn id="5" idx="0"/>
            </p:cNvCxnSpPr>
            <p:nvPr/>
          </p:nvCxnSpPr>
          <p:spPr>
            <a:xfrm flipV="1">
              <a:off x="18359997" y="5362924"/>
              <a:ext cx="720000" cy="7755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Přímá spojnice 9"/>
            <p:cNvCxnSpPr>
              <a:endCxn id="23" idx="3"/>
            </p:cNvCxnSpPr>
            <p:nvPr/>
          </p:nvCxnSpPr>
          <p:spPr>
            <a:xfrm flipV="1">
              <a:off x="16552489" y="5362924"/>
              <a:ext cx="727511" cy="9490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Přímá spojnice 10"/>
            <p:cNvCxnSpPr>
              <a:endCxn id="15" idx="3"/>
            </p:cNvCxnSpPr>
            <p:nvPr/>
          </p:nvCxnSpPr>
          <p:spPr>
            <a:xfrm flipV="1">
              <a:off x="16552489" y="8242924"/>
              <a:ext cx="727511" cy="21378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Přímá spojnice 11"/>
            <p:cNvCxnSpPr/>
            <p:nvPr/>
          </p:nvCxnSpPr>
          <p:spPr>
            <a:xfrm>
              <a:off x="18733478" y="8239046"/>
              <a:ext cx="720000" cy="1"/>
            </a:xfrm>
            <a:prstGeom prst="line">
              <a:avLst/>
            </a:prstGeom>
            <a:ln w="1905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ovéPole 12"/>
            <p:cNvSpPr txBox="1"/>
            <p:nvPr/>
          </p:nvSpPr>
          <p:spPr>
            <a:xfrm>
              <a:off x="13321655" y="4380120"/>
              <a:ext cx="2700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1055_OXA-244 (CP050381)</a:t>
              </a:r>
              <a:endParaRPr lang="cs-CZ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ovéPole 13"/>
            <p:cNvSpPr txBox="1"/>
            <p:nvPr/>
          </p:nvSpPr>
          <p:spPr>
            <a:xfrm>
              <a:off x="13321655" y="7260440"/>
              <a:ext cx="2700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co52148 (CP050382)</a:t>
              </a:r>
              <a:endParaRPr lang="cs-CZ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9" name="TextovéPole 28"/>
          <p:cNvSpPr txBox="1"/>
          <p:nvPr/>
        </p:nvSpPr>
        <p:spPr>
          <a:xfrm>
            <a:off x="129566" y="5501550"/>
            <a:ext cx="883492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S1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inear maps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6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  <a:r>
              <a:rPr lang="en-US" sz="16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OXA-244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carrying regions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rrows show the direction of transcription of open reading frames (ORFs), while truncated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ORFs appear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s rectangles (arrows within rectangles indicate the direction of transcription).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sistanc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enes are shown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in red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. IS elements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r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hown in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yellow. The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remaining genes are shown in white. Homologous segments (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ing ≥99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% sequence identity) are indicated by light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grey shading.</a:t>
            </a:r>
            <a:endParaRPr lang="cs-CZ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22911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6</TotalTime>
  <Words>93</Words>
  <Application>Microsoft Office PowerPoint</Application>
  <PresentationFormat>Předvádění na obrazovce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pagiannitsis</dc:creator>
  <cp:lastModifiedBy>papagiannitsis</cp:lastModifiedBy>
  <cp:revision>6</cp:revision>
  <dcterms:created xsi:type="dcterms:W3CDTF">2020-03-26T22:20:53Z</dcterms:created>
  <dcterms:modified xsi:type="dcterms:W3CDTF">2021-01-14T11:10:19Z</dcterms:modified>
</cp:coreProperties>
</file>